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907588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AD15B10-0C3A-45A4-AF91-A1F70D09D71A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002296-A916-495E-9D38-46832F699205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676521D-8B27-4552-B094-6A4368C39D67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3112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725800"/>
            <a:ext cx="1987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38B85D-92B9-4BC2-B168-95AABA8CDD3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811E66A-A2D0-4D73-B3D6-ED8EB37C87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593AEFC-C725-4E41-BBBD-A92331F6AF4F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C3E8228-2898-4092-AB14-048A1883DEF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33A1E2E-5F00-4FF9-A8B0-90338AC89DF4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96360"/>
            <a:ext cx="6172200" cy="76557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418557-EDF8-4C6E-8C42-A032CB82854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2B98DEC-730D-4A7C-B732-50306367F06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7258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7E11C82-B1D6-4A8A-B242-D10264B28334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311200"/>
            <a:ext cx="301176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725800"/>
            <a:ext cx="6172200" cy="3117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DB6D790-B83D-4580-B802-E83FFD5570E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96360"/>
            <a:ext cx="6172200" cy="16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311200"/>
            <a:ext cx="6172200" cy="65372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9020160"/>
            <a:ext cx="217152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9020160"/>
            <a:ext cx="1600200" cy="689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0E87ABC7-2486-4C08-9750-D886EAE672A2}" type="slidenum">
              <a:rPr b="0" lang="en-US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2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-171360" y="1281240"/>
            <a:ext cx="6837120" cy="6413400"/>
            <a:chOff x="-171360" y="1281240"/>
            <a:chExt cx="6837120" cy="6413400"/>
          </a:xfrm>
        </p:grpSpPr>
        <p:sp>
          <p:nvSpPr>
            <p:cNvPr id="42" name=""/>
            <p:cNvSpPr/>
            <p:nvPr/>
          </p:nvSpPr>
          <p:spPr>
            <a:xfrm>
              <a:off x="4379760" y="5102280"/>
              <a:ext cx="7092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4367160" y="3565440"/>
              <a:ext cx="7092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4360680" y="3473640"/>
              <a:ext cx="70920" cy="7272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040" bIns="5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3757320" y="2716200"/>
              <a:ext cx="7128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4803480" y="2813040"/>
              <a:ext cx="7128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920520" y="5102280"/>
              <a:ext cx="7128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801880" y="3048120"/>
              <a:ext cx="7092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3568680" y="3728880"/>
              <a:ext cx="7092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3608280" y="3816360"/>
              <a:ext cx="7092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3622320" y="3911760"/>
              <a:ext cx="71280" cy="7272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040" bIns="5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3622320" y="4002120"/>
              <a:ext cx="7128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3776400" y="4492800"/>
              <a:ext cx="71280" cy="7272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040" bIns="504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4360680" y="3387600"/>
              <a:ext cx="7092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4539960" y="3819600"/>
              <a:ext cx="7128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4376520" y="4075200"/>
              <a:ext cx="7128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4941720" y="5707080"/>
              <a:ext cx="7092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5109840" y="5783400"/>
              <a:ext cx="7128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5398920" y="3132000"/>
              <a:ext cx="7092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5462280" y="3389400"/>
              <a:ext cx="71280" cy="73080"/>
            </a:xfrm>
            <a:prstGeom prst="ellipse">
              <a:avLst/>
            </a:prstGeom>
            <a:solidFill>
              <a:srgbClr val="ff3399"/>
            </a:solidFill>
            <a:ln w="93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5400" bIns="54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61" name=""/>
            <p:cNvGrpSpPr/>
            <p:nvPr/>
          </p:nvGrpSpPr>
          <p:grpSpPr>
            <a:xfrm>
              <a:off x="-171360" y="1281240"/>
              <a:ext cx="6837120" cy="6413400"/>
              <a:chOff x="-171360" y="1281240"/>
              <a:chExt cx="6837120" cy="6413400"/>
            </a:xfrm>
          </p:grpSpPr>
          <p:pic>
            <p:nvPicPr>
              <p:cNvPr id="62" name="" descr=""/>
              <p:cNvPicPr/>
              <p:nvPr/>
            </p:nvPicPr>
            <p:blipFill>
              <a:blip r:embed="rId1"/>
              <a:stretch/>
            </p:blipFill>
            <p:spPr>
              <a:xfrm>
                <a:off x="-171360" y="1281240"/>
                <a:ext cx="6837120" cy="570852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63" name=""/>
              <p:cNvSpPr/>
              <p:nvPr/>
            </p:nvSpPr>
            <p:spPr>
              <a:xfrm>
                <a:off x="515880" y="7296120"/>
                <a:ext cx="5832000" cy="39852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1" lang="en-US" sz="1000" spc="-1" strike="noStrike">
                    <a:solidFill>
                      <a:srgbClr val="000000"/>
                    </a:solidFill>
                    <a:latin typeface="Calibri"/>
                  </a:rPr>
                  <a:t>Figure S1. 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Calibri"/>
                  </a:rPr>
                  <a:t>Genomic view of </a:t>
                </a:r>
                <a:r>
                  <a:rPr b="1" i="1" lang="en-US" sz="1000" spc="-1" strike="noStrike">
                    <a:solidFill>
                      <a:srgbClr val="000000"/>
                    </a:solidFill>
                    <a:latin typeface="Calibri"/>
                  </a:rPr>
                  <a:t>Star</a:t>
                </a:r>
                <a:r>
                  <a:rPr b="1" lang="en-US" sz="1000" spc="-1" strike="noStrike">
                    <a:solidFill>
                      <a:srgbClr val="000000"/>
                    </a:solidFill>
                    <a:latin typeface="Calibri"/>
                  </a:rPr>
                  <a:t> gene related RNA and EST sequences.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</a:rPr>
                  <a:t> The potential antisense transcripts (NATs predicted </a:t>
                </a:r>
                <a:r>
                  <a:rPr b="0" i="1" lang="en-US" sz="1000" spc="-1" strike="noStrike">
                    <a:solidFill>
                      <a:srgbClr val="000000"/>
                    </a:solidFill>
                    <a:latin typeface="Calibri"/>
                  </a:rPr>
                  <a:t>in silico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Calibri"/>
                  </a:rPr>
                  <a:t>) are highlighted with a pink circle in front of the sequence name. 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28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1-02-07T23:13:10Z</dcterms:created>
  <dc:creator>Fernanda</dc:creator>
  <dc:description/>
  <dc:language>en-US</dc:language>
  <cp:lastModifiedBy>Fernanda</cp:lastModifiedBy>
  <dcterms:modified xsi:type="dcterms:W3CDTF">2011-03-02T15:24:39Z</dcterms:modified>
  <cp:revision>14</cp:revision>
  <dc:subject/>
  <dc:title>Diapositiva 1</dc:title>
</cp:coreProperties>
</file>